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20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A584FF-49A2-1DE4-5E79-08E791B28D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EC0FE91-8BE3-DFCC-0BE3-B83F6D5A74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3AC11C-4DBF-92FD-EB7E-73B305639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84436B-5265-E0CC-899E-EB511628A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37E832-011F-FD52-96E4-74B32FC48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293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D2778A-934A-3364-A9E5-D61864C5C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FC2193-700D-DE30-9C11-B4084A8A37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5AAC71-9620-D0E2-9E0C-DC6803223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341C8F-9A64-3348-2100-9E4C049AC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65104C-DA64-E96F-1B99-B1787218F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591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AEC848C-1EB3-3E0B-E3FB-1A63D32F6E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B2C8E33-F456-64C5-6E43-075E431470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B410FF-9D48-A3D6-A4D0-B4B23950A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194D3F-E52F-4C2B-5A5B-D90AE1A27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4AD742-F151-B506-4154-FAF441263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19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29EAC5-7687-FE6B-B593-B107F90F4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FBD74A9-B803-CCC9-795D-4D049989E3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DB685E-422C-09B3-DF53-F8CF6AF20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57B6B8-2FE2-10F7-DE9F-0297758EB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49932B-7A69-17EA-AB9A-044FE98DC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544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257DB7-F96A-D4E7-4E08-CAD485A40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CEBD86-933B-EB3E-EAC7-FF76008BA5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2991BE-0764-A991-2024-4AF0C36A2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047631-7E82-9BFD-C765-2CDC34811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DB025D-92D7-1677-9E05-A22B77D5F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58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B27F21-7A1D-E817-5CBB-77389933FB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9E42105-BF47-53FD-D5D2-3FA2EF61E3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477262-2500-B05A-54CD-F93146794B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59A0C0C-DFAB-7759-ECD2-C85A7F7FC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2FC692-C592-F840-923C-0AC45DEE6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429C20-0236-E990-54EC-1E4350487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027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F6B28C-8A5A-8D2E-1856-1C0E3DA1F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2D0ECA-D83E-8B14-1D2A-3D4838E6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904181C-39BC-E0D4-0EC3-ABCAFFE43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87DF30C-4A25-967F-C438-178B812D2B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C1CC019-68DB-58EE-112F-B22C495CA1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4FB3BA6-2827-2CA3-E5D0-53CC5B412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E0C6840-B9F7-F2BF-B80F-AEC7D1CD1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769955-ED16-4D6F-DD44-832832EB5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4448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2D5E86-57A7-019E-1A85-686A7F5365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DD53B8E-283D-3F78-197D-2F07142A1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261FA00-6AB4-D18D-361F-CA77DE819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0E6D804-D89E-F793-9153-9FB9FD6CA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5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6EDBBC9-776A-DDE2-E164-461D572FF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0D1A60D-A4BE-CBDF-E0A4-62F1F5B8F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63A8B32-7DA3-EA31-3963-7AE339121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334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AF4EB-8743-2FAD-4F4E-FCA6B5CAA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848083-BDA7-FE00-5085-F09FB08F29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A72FF6-CD48-8805-116C-1E8940C7F4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AB57A9-377B-0662-E241-A098B436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0ED9DC0-CAE7-9D95-EF7C-C105C5D43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7492CF0-E5F0-0212-D30C-7FFC70490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033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89D402-9EA9-F660-04F9-568EB0795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F8F5B5F-3BC5-E3D4-DE10-9711EDC991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68E0CC-A824-554D-1794-28FFF1B511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597B69-9A13-8196-F6CC-D35AA582D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05AD4A-B3B5-12BD-9CFA-6228B32AD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8759DE-70DD-7E6A-5057-414DA4F7D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8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D8F6A26-D969-5505-3FE8-1DA7299B7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5AB325-D862-DFD2-BD38-B3949095E0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949120-A90A-6835-042E-3CC9BF59BC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32889-3E14-48EB-8974-1D901C3C34F8}" type="datetimeFigureOut">
              <a:rPr kumimoji="1" lang="ja-JP" altLang="en-US" smtClean="0"/>
              <a:t>2024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8FC23A-CBE5-8B97-02F2-75BC206810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D64CB32-FF74-C1CB-441C-C7639A1F37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4D747-743C-40E1-9F75-FDE77A9A1C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537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1" name="グループ化 200">
            <a:extLst>
              <a:ext uri="{FF2B5EF4-FFF2-40B4-BE49-F238E27FC236}">
                <a16:creationId xmlns:a16="http://schemas.microsoft.com/office/drawing/2014/main" id="{E75DAA8D-3EF3-F9B3-1A4C-B751E7961159}"/>
              </a:ext>
            </a:extLst>
          </p:cNvPr>
          <p:cNvGrpSpPr/>
          <p:nvPr/>
        </p:nvGrpSpPr>
        <p:grpSpPr>
          <a:xfrm>
            <a:off x="484582" y="308148"/>
            <a:ext cx="8709046" cy="6328099"/>
            <a:chOff x="2228312" y="258527"/>
            <a:chExt cx="8709046" cy="632809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EF76AAAA-8A60-1977-9617-119E056492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28312" y="258527"/>
              <a:ext cx="8709046" cy="6328099"/>
            </a:xfrm>
            <a:prstGeom prst="rect">
              <a:avLst/>
            </a:prstGeom>
          </p:spPr>
        </p:pic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B04B5964-726A-D1AF-E829-B75319FF49F4}"/>
                </a:ext>
              </a:extLst>
            </p:cNvPr>
            <p:cNvSpPr/>
            <p:nvPr/>
          </p:nvSpPr>
          <p:spPr>
            <a:xfrm>
              <a:off x="2466215" y="413023"/>
              <a:ext cx="2711777" cy="5626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4C08831-8FF2-FD5A-6054-CE1B4258FB76}"/>
              </a:ext>
            </a:extLst>
          </p:cNvPr>
          <p:cNvSpPr txBox="1"/>
          <p:nvPr/>
        </p:nvSpPr>
        <p:spPr>
          <a:xfrm>
            <a:off x="562555" y="744440"/>
            <a:ext cx="2949680" cy="5189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ja-JP" altLang="ja-JP" sz="140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・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Health check-up</a:t>
            </a:r>
          </a:p>
          <a:p>
            <a:pPr>
              <a:lnSpc>
                <a:spcPts val="1900"/>
              </a:lnSpc>
            </a:pPr>
            <a:endParaRPr lang="en-US" altLang="ja-JP" sz="1400" b="1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　</a:t>
            </a: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endParaRPr lang="en-US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ional health insurance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employee)</a:t>
            </a:r>
          </a:p>
          <a:p>
            <a:pPr>
              <a:lnSpc>
                <a:spcPts val="1900"/>
              </a:lnSpc>
            </a:pPr>
            <a:endParaRPr lang="en-US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endParaRPr lang="en-US" altLang="ja-JP" sz="1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ts val="1900"/>
              </a:lnSpc>
            </a:pPr>
            <a:r>
              <a:rPr lang="ja-JP" alt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　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ployee insurance(family)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F5A3144-6778-58CA-740D-B9945947BDF6}"/>
              </a:ext>
            </a:extLst>
          </p:cNvPr>
          <p:cNvSpPr txBox="1"/>
          <p:nvPr/>
        </p:nvSpPr>
        <p:spPr>
          <a:xfrm>
            <a:off x="3427198" y="6395028"/>
            <a:ext cx="6149196" cy="308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900"/>
              </a:lnSpc>
            </a:pPr>
            <a:r>
              <a:rPr lang="en-US" altLang="ja-JP" sz="11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Prevalence ratio (husbands undergoing wellness examinations) with 95% confidence intervals</a:t>
            </a:r>
            <a:endParaRPr lang="en-US" altLang="ja-JP" sz="1100" b="1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861F439-A160-BF63-EE88-4F089EDF26FD}"/>
              </a:ext>
            </a:extLst>
          </p:cNvPr>
          <p:cNvSpPr txBox="1"/>
          <p:nvPr/>
        </p:nvSpPr>
        <p:spPr>
          <a:xfrm rot="10800000">
            <a:off x="-22825" y="887880"/>
            <a:ext cx="428322" cy="486555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altLang="ja-JP" sz="11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ype of wellness examination by medical insurance type of husband</a:t>
            </a:r>
            <a:endParaRPr lang="en-US" altLang="ja-JP" sz="1100" b="1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7924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61</TotalTime>
  <Words>44</Words>
  <Application>Microsoft Office PowerPoint</Application>
  <PresentationFormat>ワイド画面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渡邊 多永子</dc:creator>
  <cp:lastModifiedBy>多永子 渡邊</cp:lastModifiedBy>
  <cp:revision>30</cp:revision>
  <dcterms:created xsi:type="dcterms:W3CDTF">2023-06-28T12:05:12Z</dcterms:created>
  <dcterms:modified xsi:type="dcterms:W3CDTF">2024-03-21T09:19:53Z</dcterms:modified>
</cp:coreProperties>
</file>